
<file path=[Content_Types].xml><?xml version="1.0" encoding="utf-8"?>
<Types xmlns="http://schemas.openxmlformats.org/package/2006/content-types">
  <Default Extension="jpg" ContentType="image/jp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</p:sldIdLst>
  <p:sldSz cx="12192000" cy="6858000"/>
  <p:notesSz cx="12192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265F540-E8DD-4A18-AB28-8C9913613B73}" v="1" dt="2024-04-11T15:39:12.556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678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varajan,Eswaran" userId="aad2c616-30ee-4e19-a463-6aea41bf38a4" providerId="ADAL" clId="{F79A9FFE-4E6E-4137-B714-DE4C2AA60457}"/>
    <pc:docChg chg="modSld">
      <pc:chgData name="Devarajan,Eswaran" userId="aad2c616-30ee-4e19-a463-6aea41bf38a4" providerId="ADAL" clId="{F79A9FFE-4E6E-4137-B714-DE4C2AA60457}" dt="2023-05-08T19:29:22.974" v="3" actId="20577"/>
      <pc:docMkLst>
        <pc:docMk/>
      </pc:docMkLst>
      <pc:sldChg chg="modSp">
        <pc:chgData name="Devarajan,Eswaran" userId="aad2c616-30ee-4e19-a463-6aea41bf38a4" providerId="ADAL" clId="{F79A9FFE-4E6E-4137-B714-DE4C2AA60457}" dt="2023-05-08T19:29:22.974" v="3" actId="20577"/>
        <pc:sldMkLst>
          <pc:docMk/>
          <pc:sldMk cId="0" sldId="258"/>
        </pc:sldMkLst>
        <pc:spChg chg="mod">
          <ac:chgData name="Devarajan,Eswaran" userId="aad2c616-30ee-4e19-a463-6aea41bf38a4" providerId="ADAL" clId="{F79A9FFE-4E6E-4137-B714-DE4C2AA60457}" dt="2023-05-08T19:29:19.664" v="1" actId="20577"/>
          <ac:spMkLst>
            <pc:docMk/>
            <pc:sldMk cId="0" sldId="258"/>
            <ac:spMk id="2" creationId="{00000000-0000-0000-0000-000000000000}"/>
          </ac:spMkLst>
        </pc:spChg>
        <pc:spChg chg="mod">
          <ac:chgData name="Devarajan,Eswaran" userId="aad2c616-30ee-4e19-a463-6aea41bf38a4" providerId="ADAL" clId="{F79A9FFE-4E6E-4137-B714-DE4C2AA60457}" dt="2023-05-08T19:29:22.974" v="3" actId="20577"/>
          <ac:spMkLst>
            <pc:docMk/>
            <pc:sldMk cId="0" sldId="258"/>
            <ac:spMk id="3" creationId="{00000000-0000-0000-0000-000000000000}"/>
          </ac:spMkLst>
        </pc:spChg>
      </pc:sldChg>
    </pc:docChg>
  </pc:docChgLst>
  <pc:docChgLst>
    <pc:chgData name="Devarajan,Eswaran" userId="aad2c616-30ee-4e19-a463-6aea41bf38a4" providerId="ADAL" clId="{B265F540-E8DD-4A18-AB28-8C9913613B73}"/>
    <pc:docChg chg="modSld">
      <pc:chgData name="Devarajan,Eswaran" userId="aad2c616-30ee-4e19-a463-6aea41bf38a4" providerId="ADAL" clId="{B265F540-E8DD-4A18-AB28-8C9913613B73}" dt="2024-04-11T15:39:21.217" v="4" actId="1076"/>
      <pc:docMkLst>
        <pc:docMk/>
      </pc:docMkLst>
      <pc:sldChg chg="addSp modSp mod">
        <pc:chgData name="Devarajan,Eswaran" userId="aad2c616-30ee-4e19-a463-6aea41bf38a4" providerId="ADAL" clId="{B265F540-E8DD-4A18-AB28-8C9913613B73}" dt="2024-04-11T15:39:21.217" v="4" actId="1076"/>
        <pc:sldMkLst>
          <pc:docMk/>
          <pc:sldMk cId="0" sldId="258"/>
        </pc:sldMkLst>
        <pc:spChg chg="add mod">
          <ac:chgData name="Devarajan,Eswaran" userId="aad2c616-30ee-4e19-a463-6aea41bf38a4" providerId="ADAL" clId="{B265F540-E8DD-4A18-AB28-8C9913613B73}" dt="2024-04-11T15:39:21.217" v="4" actId="1076"/>
          <ac:spMkLst>
            <pc:docMk/>
            <pc:sldMk cId="0" sldId="258"/>
            <ac:spMk id="5" creationId="{77FCB57E-3EDB-9F4C-C7CD-D77094E29672}"/>
          </ac:spMkLst>
        </pc:spChg>
      </pc:sldChg>
    </pc:docChg>
  </pc:docChgLst>
  <pc:docChgLst>
    <pc:chgData name="Eswaran Devarajan" userId="aad2c616-30ee-4e19-a463-6aea41bf38a4" providerId="ADAL" clId="{3CF74256-52F1-4BD3-B085-3350581F5AA2}"/>
    <pc:docChg chg="modSld">
      <pc:chgData name="Eswaran Devarajan" userId="aad2c616-30ee-4e19-a463-6aea41bf38a4" providerId="ADAL" clId="{3CF74256-52F1-4BD3-B085-3350581F5AA2}" dt="2023-04-10T19:55:05.100" v="3" actId="20577"/>
      <pc:docMkLst>
        <pc:docMk/>
      </pc:docMkLst>
      <pc:sldChg chg="modSp">
        <pc:chgData name="Eswaran Devarajan" userId="aad2c616-30ee-4e19-a463-6aea41bf38a4" providerId="ADAL" clId="{3CF74256-52F1-4BD3-B085-3350581F5AA2}" dt="2023-04-10T19:55:05.100" v="3" actId="20577"/>
        <pc:sldMkLst>
          <pc:docMk/>
          <pc:sldMk cId="0" sldId="258"/>
        </pc:sldMkLst>
        <pc:spChg chg="mod">
          <ac:chgData name="Eswaran Devarajan" userId="aad2c616-30ee-4e19-a463-6aea41bf38a4" providerId="ADAL" clId="{3CF74256-52F1-4BD3-B085-3350581F5AA2}" dt="2023-04-10T19:55:01.537" v="1" actId="20577"/>
          <ac:spMkLst>
            <pc:docMk/>
            <pc:sldMk cId="0" sldId="258"/>
            <ac:spMk id="2" creationId="{00000000-0000-0000-0000-000000000000}"/>
          </ac:spMkLst>
        </pc:spChg>
        <pc:spChg chg="mod">
          <ac:chgData name="Eswaran Devarajan" userId="aad2c616-30ee-4e19-a463-6aea41bf38a4" providerId="ADAL" clId="{3CF74256-52F1-4BD3-B085-3350581F5AA2}" dt="2023-04-10T19:55:05.100" v="3" actId="20577"/>
          <ac:spMkLst>
            <pc:docMk/>
            <pc:sldMk cId="0" sldId="258"/>
            <ac:spMk id="3" creationId="{00000000-0000-0000-0000-000000000000}"/>
          </ac:spMkLst>
        </pc:spChg>
      </pc:sldChg>
    </pc:docChg>
  </pc:docChgLst>
  <pc:docChgLst>
    <pc:chgData name="Devarajan,Eswaran" userId="aad2c616-30ee-4e19-a463-6aea41bf38a4" providerId="ADAL" clId="{1CEA2B48-450E-43F0-85C3-614DBAACA092}"/>
    <pc:docChg chg="modSld">
      <pc:chgData name="Devarajan,Eswaran" userId="aad2c616-30ee-4e19-a463-6aea41bf38a4" providerId="ADAL" clId="{1CEA2B48-450E-43F0-85C3-614DBAACA092}" dt="2023-10-26T15:17:50.106" v="3" actId="20577"/>
      <pc:docMkLst>
        <pc:docMk/>
      </pc:docMkLst>
      <pc:sldChg chg="modSp">
        <pc:chgData name="Devarajan,Eswaran" userId="aad2c616-30ee-4e19-a463-6aea41bf38a4" providerId="ADAL" clId="{1CEA2B48-450E-43F0-85C3-614DBAACA092}" dt="2023-10-26T15:17:50.106" v="3" actId="20577"/>
        <pc:sldMkLst>
          <pc:docMk/>
          <pc:sldMk cId="0" sldId="258"/>
        </pc:sldMkLst>
        <pc:spChg chg="mod">
          <ac:chgData name="Devarajan,Eswaran" userId="aad2c616-30ee-4e19-a463-6aea41bf38a4" providerId="ADAL" clId="{1CEA2B48-450E-43F0-85C3-614DBAACA092}" dt="2023-10-26T15:17:45.985" v="1" actId="20577"/>
          <ac:spMkLst>
            <pc:docMk/>
            <pc:sldMk cId="0" sldId="258"/>
            <ac:spMk id="2" creationId="{00000000-0000-0000-0000-000000000000}"/>
          </ac:spMkLst>
        </pc:spChg>
        <pc:spChg chg="mod">
          <ac:chgData name="Devarajan,Eswaran" userId="aad2c616-30ee-4e19-a463-6aea41bf38a4" providerId="ADAL" clId="{1CEA2B48-450E-43F0-85C3-614DBAACA092}" dt="2023-10-26T15:17:50.106" v="3" actId="20577"/>
          <ac:spMkLst>
            <pc:docMk/>
            <pc:sldMk cId="0" sldId="258"/>
            <ac:spMk id="3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4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11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11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11/2024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11/2024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Blank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854963" y="1066800"/>
            <a:ext cx="5069585" cy="3790949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g object 17"/>
          <p:cNvSpPr/>
          <p:nvPr/>
        </p:nvSpPr>
        <p:spPr>
          <a:xfrm>
            <a:off x="6035040" y="1066800"/>
            <a:ext cx="5069585" cy="3790949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11/2024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226364" y="119989"/>
            <a:ext cx="11739270" cy="29972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 sz="1800" b="0" i="0">
                <a:solidFill>
                  <a:schemeClr val="tx1"/>
                </a:solidFill>
                <a:latin typeface="Calibri"/>
                <a:cs typeface="Calibri"/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8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4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4/11/2024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33997" y="1080009"/>
            <a:ext cx="21018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2400" b="1" dirty="0">
                <a:latin typeface="Calibri"/>
                <a:cs typeface="Calibri"/>
              </a:rPr>
              <a:t>a</a:t>
            </a:r>
            <a:endParaRPr sz="2400" dirty="0">
              <a:latin typeface="Calibri"/>
              <a:cs typeface="Calibri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6182348" y="1080009"/>
            <a:ext cx="196850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2400" b="1" dirty="0">
                <a:latin typeface="Calibri"/>
                <a:cs typeface="Calibri"/>
              </a:rPr>
              <a:t>b</a:t>
            </a:r>
            <a:endParaRPr sz="2400">
              <a:latin typeface="Calibri"/>
              <a:cs typeface="Calibri"/>
            </a:endParaRPr>
          </a:p>
        </p:txBody>
      </p:sp>
      <p:sp>
        <p:nvSpPr>
          <p:cNvPr id="4" name="TextBox 89">
            <a:extLst>
              <a:ext uri="{FF2B5EF4-FFF2-40B4-BE49-F238E27FC236}">
                <a16:creationId xmlns:a16="http://schemas.microsoft.com/office/drawing/2014/main" id="{96CB5D5F-F477-4FC8-BA50-0BE372364FAC}"/>
              </a:ext>
            </a:extLst>
          </p:cNvPr>
          <p:cNvSpPr txBox="1"/>
          <p:nvPr/>
        </p:nvSpPr>
        <p:spPr>
          <a:xfrm>
            <a:off x="620545" y="304800"/>
            <a:ext cx="1047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Figure</a:t>
            </a:r>
            <a:r>
              <a:rPr lang="en-US"/>
              <a:t>.S3</a:t>
            </a:r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7FCB57E-3EDB-9F4C-C7CD-D77094E29672}"/>
              </a:ext>
            </a:extLst>
          </p:cNvPr>
          <p:cNvSpPr txBox="1"/>
          <p:nvPr/>
        </p:nvSpPr>
        <p:spPr>
          <a:xfrm>
            <a:off x="1144182" y="5410200"/>
            <a:ext cx="95045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Examples of H3K27me3 labeling intensity in osteosarcoma patient tumor samples.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Strong. (b) Non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3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waran Devarajan</dc:creator>
  <cp:lastModifiedBy>Devarajan,Eswaran</cp:lastModifiedBy>
  <cp:revision>4</cp:revision>
  <dcterms:created xsi:type="dcterms:W3CDTF">2022-11-10T16:29:00Z</dcterms:created>
  <dcterms:modified xsi:type="dcterms:W3CDTF">2024-04-11T15:39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2-07-11T00:00:00Z</vt:filetime>
  </property>
  <property fmtid="{D5CDD505-2E9C-101B-9397-08002B2CF9AE}" pid="3" name="Creator">
    <vt:lpwstr>Acrobat PDFMaker 22 for PowerPoint</vt:lpwstr>
  </property>
  <property fmtid="{D5CDD505-2E9C-101B-9397-08002B2CF9AE}" pid="4" name="LastSaved">
    <vt:filetime>2022-11-10T00:00:00Z</vt:filetime>
  </property>
</Properties>
</file>